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56" r:id="rId2"/>
    <p:sldId id="257" r:id="rId3"/>
    <p:sldId id="258" r:id="rId4"/>
    <p:sldId id="264" r:id="rId5"/>
    <p:sldId id="260" r:id="rId6"/>
    <p:sldId id="262" r:id="rId7"/>
    <p:sldId id="261" r:id="rId8"/>
    <p:sldId id="263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3" name="Heather F. Campbell" initials="HFC" lastIdx="6" clrIdx="0">
    <p:extLst>
      <p:ext uri="{19B8F6BF-5375-455C-9EA6-DF929625EA0E}">
        <p15:presenceInfo xmlns:p15="http://schemas.microsoft.com/office/powerpoint/2012/main" userId="S-1-5-21-1004336348-1409082233-839522115-5615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6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image" Target="../media/image19.emf"/><Relationship Id="rId4" Type="http://schemas.openxmlformats.org/officeDocument/2006/relationships/image" Target="../media/image2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4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49.emf"/><Relationship Id="rId1" Type="http://schemas.openxmlformats.org/officeDocument/2006/relationships/image" Target="../media/image48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61.emf"/><Relationship Id="rId3" Type="http://schemas.openxmlformats.org/officeDocument/2006/relationships/image" Target="../media/image56.emf"/><Relationship Id="rId7" Type="http://schemas.openxmlformats.org/officeDocument/2006/relationships/image" Target="../media/image60.emf"/><Relationship Id="rId2" Type="http://schemas.openxmlformats.org/officeDocument/2006/relationships/image" Target="../media/image55.emf"/><Relationship Id="rId1" Type="http://schemas.openxmlformats.org/officeDocument/2006/relationships/image" Target="../media/image54.emf"/><Relationship Id="rId6" Type="http://schemas.openxmlformats.org/officeDocument/2006/relationships/image" Target="../media/image59.emf"/><Relationship Id="rId5" Type="http://schemas.openxmlformats.org/officeDocument/2006/relationships/image" Target="../media/image58.emf"/><Relationship Id="rId10" Type="http://schemas.openxmlformats.org/officeDocument/2006/relationships/image" Target="../media/image63.emf"/><Relationship Id="rId4" Type="http://schemas.openxmlformats.org/officeDocument/2006/relationships/image" Target="../media/image57.emf"/><Relationship Id="rId9" Type="http://schemas.openxmlformats.org/officeDocument/2006/relationships/image" Target="../media/image62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934114-8B0F-4678-AC46-BC6C06376974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7C2414-95BD-41A3-B7F6-CAE4346A12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1464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36A009-7473-4064-A0F6-F723E970D74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6600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i="0" dirty="0">
              <a:solidFill>
                <a:srgbClr val="FF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36A009-7473-4064-A0F6-F723E970D74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071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FA3DBD-D810-4509-9B8A-670B6FE6537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9501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FA3DBD-D810-4509-9B8A-670B6FE6537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94503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36A009-7473-4064-A0F6-F723E970D74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24404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36A009-7473-4064-A0F6-F723E970D74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3278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36A009-7473-4064-A0F6-F723E970D741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7668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742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974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49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028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283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897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147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199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095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911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658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D4D7B-9846-4E57-A324-688ACE8FCD13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DD90BB-3C69-4F3B-8AD0-E3E0A1089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674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18" Type="http://schemas.openxmlformats.org/officeDocument/2006/relationships/image" Target="../media/image1.emf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16.png"/><Relationship Id="rId7" Type="http://schemas.openxmlformats.org/officeDocument/2006/relationships/image" Target="../media/image6.png"/><Relationship Id="rId12" Type="http://schemas.openxmlformats.org/officeDocument/2006/relationships/image" Target="../media/image11.jpeg"/><Relationship Id="rId17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5.tiff"/><Relationship Id="rId20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png"/><Relationship Id="rId15" Type="http://schemas.openxmlformats.org/officeDocument/2006/relationships/image" Target="../media/image14.tiff"/><Relationship Id="rId23" Type="http://schemas.openxmlformats.org/officeDocument/2006/relationships/image" Target="../media/image18.png"/><Relationship Id="rId10" Type="http://schemas.openxmlformats.org/officeDocument/2006/relationships/image" Target="../media/image9.jpeg"/><Relationship Id="rId19" Type="http://schemas.openxmlformats.org/officeDocument/2006/relationships/oleObject" Target="../embeddings/oleObject2.bin"/><Relationship Id="rId4" Type="http://schemas.openxmlformats.org/officeDocument/2006/relationships/image" Target="../media/image3.png"/><Relationship Id="rId9" Type="http://schemas.openxmlformats.org/officeDocument/2006/relationships/image" Target="../media/image8.tiff"/><Relationship Id="rId14" Type="http://schemas.openxmlformats.org/officeDocument/2006/relationships/image" Target="../media/image13.jpeg"/><Relationship Id="rId22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f"/><Relationship Id="rId13" Type="http://schemas.openxmlformats.org/officeDocument/2006/relationships/image" Target="../media/image19.emf"/><Relationship Id="rId18" Type="http://schemas.openxmlformats.org/officeDocument/2006/relationships/oleObject" Target="../embeddings/oleObject6.bin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32.png"/><Relationship Id="rId7" Type="http://schemas.openxmlformats.org/officeDocument/2006/relationships/image" Target="../media/image26.jpeg"/><Relationship Id="rId12" Type="http://schemas.openxmlformats.org/officeDocument/2006/relationships/oleObject" Target="../embeddings/oleObject3.bin"/><Relationship Id="rId17" Type="http://schemas.openxmlformats.org/officeDocument/2006/relationships/image" Target="../media/image21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5.bin"/><Relationship Id="rId20" Type="http://schemas.openxmlformats.org/officeDocument/2006/relationships/image" Target="../media/image31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25.tiff"/><Relationship Id="rId11" Type="http://schemas.openxmlformats.org/officeDocument/2006/relationships/image" Target="../media/image30.jpeg"/><Relationship Id="rId5" Type="http://schemas.openxmlformats.org/officeDocument/2006/relationships/image" Target="../media/image24.jpeg"/><Relationship Id="rId15" Type="http://schemas.openxmlformats.org/officeDocument/2006/relationships/image" Target="../media/image20.emf"/><Relationship Id="rId10" Type="http://schemas.openxmlformats.org/officeDocument/2006/relationships/image" Target="../media/image29.tiff"/><Relationship Id="rId19" Type="http://schemas.openxmlformats.org/officeDocument/2006/relationships/image" Target="../media/image22.emf"/><Relationship Id="rId4" Type="http://schemas.openxmlformats.org/officeDocument/2006/relationships/image" Target="../media/image23.tiff"/><Relationship Id="rId9" Type="http://schemas.openxmlformats.org/officeDocument/2006/relationships/image" Target="../media/image28.jpeg"/><Relationship Id="rId14" Type="http://schemas.openxmlformats.org/officeDocument/2006/relationships/oleObject" Target="../embeddings/oleObject4.bin"/><Relationship Id="rId22" Type="http://schemas.openxmlformats.org/officeDocument/2006/relationships/image" Target="../media/image3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microsoft.com/office/2007/relationships/hdphoto" Target="../media/hdphoto5.wdp"/><Relationship Id="rId3" Type="http://schemas.openxmlformats.org/officeDocument/2006/relationships/notesSlide" Target="../notesSlides/notesSlide3.xml"/><Relationship Id="rId7" Type="http://schemas.microsoft.com/office/2007/relationships/hdphoto" Target="../media/hdphoto2.wdp"/><Relationship Id="rId12" Type="http://schemas.openxmlformats.org/officeDocument/2006/relationships/image" Target="../media/image39.png"/><Relationship Id="rId17" Type="http://schemas.openxmlformats.org/officeDocument/2006/relationships/image" Target="../media/image34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36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38.png"/><Relationship Id="rId4" Type="http://schemas.openxmlformats.org/officeDocument/2006/relationships/image" Target="../media/image35.png"/><Relationship Id="rId9" Type="http://schemas.microsoft.com/office/2007/relationships/hdphoto" Target="../media/hdphoto3.wdp"/><Relationship Id="rId14" Type="http://schemas.openxmlformats.org/officeDocument/2006/relationships/image" Target="../media/image40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10" Type="http://schemas.openxmlformats.org/officeDocument/2006/relationships/image" Target="../media/image47.tiff"/><Relationship Id="rId4" Type="http://schemas.openxmlformats.org/officeDocument/2006/relationships/image" Target="../media/image42.png"/><Relationship Id="rId9" Type="http://schemas.openxmlformats.org/officeDocument/2006/relationships/image" Target="../media/image46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53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52.png"/><Relationship Id="rId11" Type="http://schemas.openxmlformats.org/officeDocument/2006/relationships/image" Target="../media/image49.emf"/><Relationship Id="rId5" Type="http://schemas.openxmlformats.org/officeDocument/2006/relationships/image" Target="../media/image51.png"/><Relationship Id="rId10" Type="http://schemas.openxmlformats.org/officeDocument/2006/relationships/oleObject" Target="../embeddings/oleObject9.bin"/><Relationship Id="rId4" Type="http://schemas.openxmlformats.org/officeDocument/2006/relationships/image" Target="../media/image50.png"/><Relationship Id="rId9" Type="http://schemas.openxmlformats.org/officeDocument/2006/relationships/image" Target="../media/image48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58.emf"/><Relationship Id="rId18" Type="http://schemas.openxmlformats.org/officeDocument/2006/relationships/oleObject" Target="../embeddings/oleObject17.bin"/><Relationship Id="rId3" Type="http://schemas.openxmlformats.org/officeDocument/2006/relationships/notesSlide" Target="../notesSlides/notesSlide6.xml"/><Relationship Id="rId21" Type="http://schemas.openxmlformats.org/officeDocument/2006/relationships/image" Target="../media/image62.emf"/><Relationship Id="rId7" Type="http://schemas.openxmlformats.org/officeDocument/2006/relationships/image" Target="../media/image55.emf"/><Relationship Id="rId12" Type="http://schemas.openxmlformats.org/officeDocument/2006/relationships/oleObject" Target="../embeddings/oleObject14.bin"/><Relationship Id="rId17" Type="http://schemas.openxmlformats.org/officeDocument/2006/relationships/image" Target="../media/image60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6.bin"/><Relationship Id="rId20" Type="http://schemas.openxmlformats.org/officeDocument/2006/relationships/oleObject" Target="../embeddings/oleObject18.bin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57.emf"/><Relationship Id="rId5" Type="http://schemas.openxmlformats.org/officeDocument/2006/relationships/image" Target="../media/image54.emf"/><Relationship Id="rId15" Type="http://schemas.openxmlformats.org/officeDocument/2006/relationships/image" Target="../media/image59.emf"/><Relationship Id="rId23" Type="http://schemas.openxmlformats.org/officeDocument/2006/relationships/image" Target="../media/image63.emf"/><Relationship Id="rId10" Type="http://schemas.openxmlformats.org/officeDocument/2006/relationships/oleObject" Target="../embeddings/oleObject13.bin"/><Relationship Id="rId19" Type="http://schemas.openxmlformats.org/officeDocument/2006/relationships/image" Target="../media/image61.emf"/><Relationship Id="rId4" Type="http://schemas.openxmlformats.org/officeDocument/2006/relationships/oleObject" Target="../embeddings/oleObject10.bin"/><Relationship Id="rId9" Type="http://schemas.openxmlformats.org/officeDocument/2006/relationships/image" Target="../media/image56.emf"/><Relationship Id="rId14" Type="http://schemas.openxmlformats.org/officeDocument/2006/relationships/oleObject" Target="../embeddings/oleObject15.bin"/><Relationship Id="rId22" Type="http://schemas.openxmlformats.org/officeDocument/2006/relationships/oleObject" Target="../embeddings/oleObject19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7" Type="http://schemas.openxmlformats.org/officeDocument/2006/relationships/image" Target="../media/image6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20.bin"/><Relationship Id="rId5" Type="http://schemas.openxmlformats.org/officeDocument/2006/relationships/image" Target="../media/image66.jpeg"/><Relationship Id="rId4" Type="http://schemas.openxmlformats.org/officeDocument/2006/relationships/image" Target="../media/image6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l Figure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5112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2185757"/>
            <a:ext cx="1647222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8178" y="228600"/>
            <a:ext cx="1647222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0778" y="228600"/>
            <a:ext cx="1647222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452" y="228600"/>
            <a:ext cx="1607148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4211" y="228600"/>
            <a:ext cx="1647222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2800" y="164072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610005" y="164072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307893" y="159884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-12800" y="2061774"/>
            <a:ext cx="437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E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362200" y="2057400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F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495800" y="2057400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G)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DA7B188C-835A-7048-B740-0B5A4ADF172A}"/>
              </a:ext>
            </a:extLst>
          </p:cNvPr>
          <p:cNvGrpSpPr>
            <a:grpSpLocks noChangeAspect="1"/>
          </p:cNvGrpSpPr>
          <p:nvPr/>
        </p:nvGrpSpPr>
        <p:grpSpPr>
          <a:xfrm>
            <a:off x="3512302" y="4297680"/>
            <a:ext cx="3193298" cy="2560320"/>
            <a:chOff x="3516868" y="3962400"/>
            <a:chExt cx="2883932" cy="2312276"/>
          </a:xfrm>
        </p:grpSpPr>
        <p:pic>
          <p:nvPicPr>
            <p:cNvPr id="27" name="Picture 26" descr="A picture containing animal&#10;&#10;Description generated with high confidence">
              <a:extLst>
                <a:ext uri="{FF2B5EF4-FFF2-40B4-BE49-F238E27FC236}">
                  <a16:creationId xmlns:a16="http://schemas.microsoft.com/office/drawing/2014/main" id="{CD1811DE-5B16-4B03-84AC-FC2456357F7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3353" y="3962400"/>
              <a:ext cx="1714500" cy="1143000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FDA07028-44A5-4A4A-A32E-7374450432E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7800" y="3962400"/>
              <a:ext cx="1143000" cy="1143000"/>
            </a:xfrm>
            <a:prstGeom prst="rect">
              <a:avLst/>
            </a:prstGeom>
          </p:spPr>
        </p:pic>
        <p:pic>
          <p:nvPicPr>
            <p:cNvPr id="30" name="Picture 29" descr="A picture containing cake, indoor&#10;&#10;Description generated with high confidence">
              <a:extLst>
                <a:ext uri="{FF2B5EF4-FFF2-40B4-BE49-F238E27FC236}">
                  <a16:creationId xmlns:a16="http://schemas.microsoft.com/office/drawing/2014/main" id="{8940A51F-714A-41B9-82FA-0256527E27F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3353" y="5131676"/>
              <a:ext cx="1714500" cy="1143000"/>
            </a:xfrm>
            <a:prstGeom prst="rect">
              <a:avLst/>
            </a:prstGeom>
          </p:spPr>
        </p:pic>
        <p:pic>
          <p:nvPicPr>
            <p:cNvPr id="31" name="Picture 30" descr="A picture containing doughnut&#10;&#10;Description generated with high confidence">
              <a:extLst>
                <a:ext uri="{FF2B5EF4-FFF2-40B4-BE49-F238E27FC236}">
                  <a16:creationId xmlns:a16="http://schemas.microsoft.com/office/drawing/2014/main" id="{F54CEFA6-7DCF-4249-89C0-1CBC4A048D7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7800" y="5131676"/>
              <a:ext cx="1143000" cy="1143000"/>
            </a:xfrm>
            <a:prstGeom prst="rect">
              <a:avLst/>
            </a:prstGeom>
          </p:spPr>
        </p:pic>
        <p:sp>
          <p:nvSpPr>
            <p:cNvPr id="34" name="TextBox 33"/>
            <p:cNvSpPr txBox="1"/>
            <p:nvPr/>
          </p:nvSpPr>
          <p:spPr>
            <a:xfrm rot="16200000">
              <a:off x="3271095" y="4337895"/>
              <a:ext cx="8608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Vehicle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3092459" y="5480895"/>
              <a:ext cx="12181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DT-Treated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575BC9D9-7398-6947-A436-0FEDD4570ACC}"/>
              </a:ext>
            </a:extLst>
          </p:cNvPr>
          <p:cNvGrpSpPr>
            <a:grpSpLocks noChangeAspect="1"/>
          </p:cNvGrpSpPr>
          <p:nvPr/>
        </p:nvGrpSpPr>
        <p:grpSpPr>
          <a:xfrm>
            <a:off x="235702" y="4297680"/>
            <a:ext cx="3151915" cy="2560320"/>
            <a:chOff x="381000" y="3962400"/>
            <a:chExt cx="2906730" cy="2361154"/>
          </a:xfrm>
        </p:grpSpPr>
        <p:pic>
          <p:nvPicPr>
            <p:cNvPr id="25" name="Picture 24" descr="A picture containing reptile, turtle, animal&#10;&#10;Description generated with high confidence">
              <a:extLst>
                <a:ext uri="{FF2B5EF4-FFF2-40B4-BE49-F238E27FC236}">
                  <a16:creationId xmlns:a16="http://schemas.microsoft.com/office/drawing/2014/main" id="{C922CC76-35D8-4E38-8851-6FBCFD76C80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3162" y="3962400"/>
              <a:ext cx="1714500" cy="1143000"/>
            </a:xfrm>
            <a:prstGeom prst="rect">
              <a:avLst/>
            </a:prstGeom>
          </p:spPr>
        </p:pic>
        <p:pic>
          <p:nvPicPr>
            <p:cNvPr id="26" name="Picture 25" descr="A picture containing animal, turtle&#10;&#10;Description generated with very high confidence">
              <a:extLst>
                <a:ext uri="{FF2B5EF4-FFF2-40B4-BE49-F238E27FC236}">
                  <a16:creationId xmlns:a16="http://schemas.microsoft.com/office/drawing/2014/main" id="{3350F187-2254-46C8-93D6-8987B76B69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730" y="3962400"/>
              <a:ext cx="1143000" cy="1143000"/>
            </a:xfrm>
            <a:prstGeom prst="rect">
              <a:avLst/>
            </a:prstGeom>
          </p:spPr>
        </p:pic>
        <p:pic>
          <p:nvPicPr>
            <p:cNvPr id="29" name="Picture 28" descr="A picture containing cake&#10;&#10;Description generated with high confidence">
              <a:extLst>
                <a:ext uri="{FF2B5EF4-FFF2-40B4-BE49-F238E27FC236}">
                  <a16:creationId xmlns:a16="http://schemas.microsoft.com/office/drawing/2014/main" id="{0F0AAA20-886C-4D51-B2DE-7C5F99B31FD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3162" y="5131676"/>
              <a:ext cx="1714500" cy="1143000"/>
            </a:xfrm>
            <a:prstGeom prst="rect">
              <a:avLst/>
            </a:prstGeom>
          </p:spPr>
        </p:pic>
        <p:pic>
          <p:nvPicPr>
            <p:cNvPr id="32" name="Picture 31" descr="A picture containing cake, X-ray film&#10;&#10;Description generated with very high confidence">
              <a:extLst>
                <a:ext uri="{FF2B5EF4-FFF2-40B4-BE49-F238E27FC236}">
                  <a16:creationId xmlns:a16="http://schemas.microsoft.com/office/drawing/2014/main" id="{6971F34B-9D23-4D0C-B3FB-B4336C61E7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730" y="5131676"/>
              <a:ext cx="1143000" cy="114300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135228" y="4337895"/>
              <a:ext cx="8608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Vehicle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-43411" y="5529811"/>
              <a:ext cx="12181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DT-Treated</a:t>
              </a: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-12800" y="3886200"/>
            <a:ext cx="470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H)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004179" y="159884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2445004" y="2185757"/>
          <a:ext cx="1779099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Prism 7" r:id="rId17" imgW="2506545" imgH="2899100" progId="Prism7.Document">
                  <p:embed/>
                </p:oleObj>
              </mc:Choice>
              <mc:Fallback>
                <p:oleObj name="Prism 7" r:id="rId17" imgW="2506545" imgH="2899100" progId="Prism7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445004" y="2185757"/>
                        <a:ext cx="1779099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4793285" y="2185757"/>
          <a:ext cx="1702482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Prism 7" r:id="rId19" imgW="2398144" imgH="2899100" progId="Prism7.Document">
                  <p:embed/>
                </p:oleObj>
              </mc:Choice>
              <mc:Fallback>
                <p:oleObj name="Prism 7" r:id="rId19" imgW="2398144" imgH="2899100" progId="Prism7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793285" y="2185757"/>
                        <a:ext cx="1702482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/>
          <p:cNvSpPr txBox="1"/>
          <p:nvPr/>
        </p:nvSpPr>
        <p:spPr>
          <a:xfrm>
            <a:off x="76200" y="-76200"/>
            <a:ext cx="14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p</a:t>
            </a:r>
            <a:r>
              <a:rPr lang="en-US" dirty="0"/>
              <a:t> Figure 1</a:t>
            </a:r>
          </a:p>
        </p:txBody>
      </p:sp>
      <p:pic>
        <p:nvPicPr>
          <p:cNvPr id="38" name="Picture 8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5757" y="6934200"/>
            <a:ext cx="1679776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9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537" y="6934200"/>
            <a:ext cx="1744884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10"/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8624" y="6934200"/>
            <a:ext cx="1679776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255638" y="6934200"/>
            <a:ext cx="383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I)</a:t>
            </a:r>
            <a:endParaRPr lang="en-US" dirty="0"/>
          </a:p>
        </p:txBody>
      </p:sp>
      <p:sp>
        <p:nvSpPr>
          <p:cNvPr id="43" name="TextBox 42"/>
          <p:cNvSpPr txBox="1"/>
          <p:nvPr/>
        </p:nvSpPr>
        <p:spPr>
          <a:xfrm>
            <a:off x="2223565" y="6934200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J)</a:t>
            </a:r>
            <a:endParaRPr lang="en-US" dirty="0"/>
          </a:p>
        </p:txBody>
      </p:sp>
      <p:sp>
        <p:nvSpPr>
          <p:cNvPr id="44" name="TextBox 43"/>
          <p:cNvSpPr txBox="1"/>
          <p:nvPr/>
        </p:nvSpPr>
        <p:spPr>
          <a:xfrm>
            <a:off x="4161556" y="6934200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K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66455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280736" y="3429523"/>
            <a:ext cx="2944504" cy="2361677"/>
            <a:chOff x="381000" y="4343400"/>
            <a:chExt cx="2944504" cy="2361677"/>
          </a:xfrm>
        </p:grpSpPr>
        <p:pic>
          <p:nvPicPr>
            <p:cNvPr id="4" name="Picture 3" descr="A picture containing indoor, cat, animal, mammal&#10;&#10;Description generated with high confidence">
              <a:extLst>
                <a:ext uri="{FF2B5EF4-FFF2-40B4-BE49-F238E27FC236}">
                  <a16:creationId xmlns:a16="http://schemas.microsoft.com/office/drawing/2014/main" id="{DD8F109F-2DC0-497C-A57D-922BE5DA660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189" y="4343400"/>
              <a:ext cx="1714500" cy="1143000"/>
            </a:xfrm>
            <a:prstGeom prst="rect">
              <a:avLst/>
            </a:prstGeom>
          </p:spPr>
        </p:pic>
        <p:pic>
          <p:nvPicPr>
            <p:cNvPr id="5" name="Picture 4" descr="A picture containing indoor, sitting&#10;&#10;Description generated with very high confidence">
              <a:extLst>
                <a:ext uri="{FF2B5EF4-FFF2-40B4-BE49-F238E27FC236}">
                  <a16:creationId xmlns:a16="http://schemas.microsoft.com/office/drawing/2014/main" id="{0962F9E5-2B7C-4C58-86C2-6F0B68DAEE9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2504" y="4343400"/>
              <a:ext cx="1143000" cy="1143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 rot="16200000">
              <a:off x="135228" y="4718895"/>
              <a:ext cx="8608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Vehicle</a:t>
              </a:r>
            </a:p>
          </p:txBody>
        </p:sp>
        <p:pic>
          <p:nvPicPr>
            <p:cNvPr id="10" name="Picture 9" descr="A picture containing photo, indoor&#10;&#10;Description generated with high confidence">
              <a:extLst>
                <a:ext uri="{FF2B5EF4-FFF2-40B4-BE49-F238E27FC236}">
                  <a16:creationId xmlns:a16="http://schemas.microsoft.com/office/drawing/2014/main" id="{70DED126-1B70-4607-ABE1-77F2BB20385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189" y="5524500"/>
              <a:ext cx="1714500" cy="1143000"/>
            </a:xfrm>
            <a:prstGeom prst="rect">
              <a:avLst/>
            </a:prstGeom>
          </p:spPr>
        </p:pic>
        <p:pic>
          <p:nvPicPr>
            <p:cNvPr id="11" name="Picture 10" descr="A picture containing cake&#10;&#10;Description generated with high confidence">
              <a:extLst>
                <a:ext uri="{FF2B5EF4-FFF2-40B4-BE49-F238E27FC236}">
                  <a16:creationId xmlns:a16="http://schemas.microsoft.com/office/drawing/2014/main" id="{19A6AF03-D00F-43D3-BA62-9AA37AE1037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2504" y="5524500"/>
              <a:ext cx="1143000" cy="114300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 rot="16200000">
              <a:off x="-43411" y="5911334"/>
              <a:ext cx="12181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DT-Treated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3657600" y="3429523"/>
            <a:ext cx="2930856" cy="2359696"/>
            <a:chOff x="3505200" y="4345382"/>
            <a:chExt cx="2930856" cy="235969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DA7B85B-EEB0-454F-A28D-2E6B1EA1C55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0272" y="4345382"/>
              <a:ext cx="1714500" cy="1143000"/>
            </a:xfrm>
            <a:prstGeom prst="rect">
              <a:avLst/>
            </a:prstGeom>
          </p:spPr>
        </p:pic>
        <p:pic>
          <p:nvPicPr>
            <p:cNvPr id="7" name="Picture 6" descr="A picture containing doughnut&#10;&#10;Description generated with high confidence">
              <a:extLst>
                <a:ext uri="{FF2B5EF4-FFF2-40B4-BE49-F238E27FC236}">
                  <a16:creationId xmlns:a16="http://schemas.microsoft.com/office/drawing/2014/main" id="{50C51C10-09A1-43CE-A5C7-07F60435241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93056" y="4345382"/>
              <a:ext cx="1143000" cy="11430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 rot="16200000">
              <a:off x="3259428" y="4667355"/>
              <a:ext cx="8608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Vehicle</a:t>
              </a:r>
            </a:p>
          </p:txBody>
        </p:sp>
        <p:pic>
          <p:nvPicPr>
            <p:cNvPr id="12" name="Picture 11" descr="A picture containing indoor&#10;&#10;Description generated with high confidence">
              <a:extLst>
                <a:ext uri="{FF2B5EF4-FFF2-40B4-BE49-F238E27FC236}">
                  <a16:creationId xmlns:a16="http://schemas.microsoft.com/office/drawing/2014/main" id="{3658BC04-A3D6-4B67-97A6-A1F1463EB4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0271" y="5524500"/>
              <a:ext cx="1714500" cy="11430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2BFA3DA-A5E8-46EB-BC7A-D6531C8DB8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93056" y="5524500"/>
              <a:ext cx="1143000" cy="114300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 rot="16200000">
              <a:off x="3080789" y="5911335"/>
              <a:ext cx="12181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DT-Treated</a:t>
              </a: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-6631" y="3104834"/>
            <a:ext cx="437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E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359236" y="31048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F)</a:t>
            </a:r>
          </a:p>
        </p:txBody>
      </p:sp>
      <p:graphicFrame>
        <p:nvGraphicFramePr>
          <p:cNvPr id="20" name="Object 19"/>
          <p:cNvGraphicFramePr>
            <a:graphicFrameLocks noChangeAspect="1"/>
          </p:cNvGraphicFramePr>
          <p:nvPr>
            <p:extLst/>
          </p:nvPr>
        </p:nvGraphicFramePr>
        <p:xfrm>
          <a:off x="112776" y="701416"/>
          <a:ext cx="1778125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6" name="Prism 6" r:id="rId12" imgW="2506545" imgH="2899960" progId="Prism6.Document">
                  <p:embed/>
                </p:oleObj>
              </mc:Choice>
              <mc:Fallback>
                <p:oleObj name="Prism 6" r:id="rId12" imgW="2506545" imgH="2899960" progId="Prism6.Document">
                  <p:embed/>
                  <p:pic>
                    <p:nvPicPr>
                      <p:cNvPr id="20" name="Object 19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12776" y="701416"/>
                        <a:ext cx="1778125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/>
          </p:nvPr>
        </p:nvGraphicFramePr>
        <p:xfrm>
          <a:off x="1905000" y="701416"/>
          <a:ext cx="1661010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7" name="Prism 6" r:id="rId14" imgW="2341602" imgH="2899960" progId="Prism6.Document">
                  <p:embed/>
                </p:oleObj>
              </mc:Choice>
              <mc:Fallback>
                <p:oleObj name="Prism 6" r:id="rId14" imgW="2341602" imgH="2899960" progId="Prism6.Document">
                  <p:embed/>
                  <p:pic>
                    <p:nvPicPr>
                      <p:cNvPr id="21" name="Object 20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905000" y="701416"/>
                        <a:ext cx="1661010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/>
          </p:nvPr>
        </p:nvGraphicFramePr>
        <p:xfrm>
          <a:off x="3505200" y="701416"/>
          <a:ext cx="1661010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8" name="Prism 6" r:id="rId16" imgW="2341602" imgH="2899960" progId="Prism6.Document">
                  <p:embed/>
                </p:oleObj>
              </mc:Choice>
              <mc:Fallback>
                <p:oleObj name="Prism 6" r:id="rId16" imgW="2341602" imgH="2899960" progId="Prism6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505200" y="701416"/>
                        <a:ext cx="1661010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/>
          </p:nvPr>
        </p:nvGraphicFramePr>
        <p:xfrm>
          <a:off x="5203747" y="701416"/>
          <a:ext cx="1654253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9" name="Prism 6" r:id="rId18" imgW="2332599" imgH="2899960" progId="Prism6.Document">
                  <p:embed/>
                </p:oleObj>
              </mc:Choice>
              <mc:Fallback>
                <p:oleObj name="Prism 6" r:id="rId18" imgW="2332599" imgH="2899960" progId="Prism6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203747" y="701416"/>
                        <a:ext cx="1654253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68580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759036" y="68580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359236" y="68580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018002" y="68580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6200" y="-76200"/>
            <a:ext cx="14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p</a:t>
            </a:r>
            <a:r>
              <a:rPr lang="en-US" dirty="0"/>
              <a:t> Figure 2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64594" y="6400800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J)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4249664" y="6400800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L)</a:t>
            </a:r>
            <a:endParaRPr lang="en-US" dirty="0"/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8049" y="6400800"/>
            <a:ext cx="1725351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3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666" y="6400800"/>
            <a:ext cx="1725351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4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0983" y="6400800"/>
            <a:ext cx="1725351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2315356" y="6400800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K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35003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F10DC5EA-CEEA-0B49-93C7-A6C51D249B11}"/>
              </a:ext>
            </a:extLst>
          </p:cNvPr>
          <p:cNvGrpSpPr/>
          <p:nvPr/>
        </p:nvGrpSpPr>
        <p:grpSpPr>
          <a:xfrm>
            <a:off x="685800" y="495626"/>
            <a:ext cx="5718118" cy="1866574"/>
            <a:chOff x="685800" y="762000"/>
            <a:chExt cx="5718118" cy="1866574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23493668-A633-E74D-80DE-4728BF8EF5A1}"/>
                </a:ext>
              </a:extLst>
            </p:cNvPr>
            <p:cNvGrpSpPr/>
            <p:nvPr/>
          </p:nvGrpSpPr>
          <p:grpSpPr>
            <a:xfrm>
              <a:off x="685800" y="762000"/>
              <a:ext cx="2488763" cy="1866574"/>
              <a:chOff x="685800" y="762000"/>
              <a:chExt cx="2488763" cy="1866574"/>
            </a:xfrm>
          </p:grpSpPr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9245D02D-B6AC-564C-BB0F-815DE414EB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5800" y="762000"/>
                <a:ext cx="2488763" cy="1866574"/>
              </a:xfrm>
              <a:prstGeom prst="rect">
                <a:avLst/>
              </a:prstGeom>
            </p:spPr>
          </p:pic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E39E7319-C48F-8541-B8D3-92B77B512465}"/>
                  </a:ext>
                </a:extLst>
              </p:cNvPr>
              <p:cNvSpPr/>
              <p:nvPr/>
            </p:nvSpPr>
            <p:spPr>
              <a:xfrm>
                <a:off x="1674163" y="1391209"/>
                <a:ext cx="504966" cy="37872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03941F68-19BF-EE4E-95B8-4800C4528DA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79129" y="762000"/>
              <a:ext cx="1732908" cy="62921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BC449F3F-36ED-2648-A15E-85F377123E15}"/>
                </a:ext>
              </a:extLst>
            </p:cNvPr>
            <p:cNvCxnSpPr>
              <a:cxnSpLocks/>
            </p:cNvCxnSpPr>
            <p:nvPr/>
          </p:nvCxnSpPr>
          <p:spPr>
            <a:xfrm>
              <a:off x="2179129" y="1769935"/>
              <a:ext cx="1732908" cy="8586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4" name="Picture 33" descr="A picture containing red, covered, fabric, large&#10;&#10;Description automatically generated">
              <a:extLst>
                <a:ext uri="{FF2B5EF4-FFF2-40B4-BE49-F238E27FC236}">
                  <a16:creationId xmlns:a16="http://schemas.microsoft.com/office/drawing/2014/main" id="{BBAFCCDA-6668-344C-9213-7CDFECBE0CC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6737" y="762000"/>
              <a:ext cx="2487181" cy="1865376"/>
            </a:xfrm>
            <a:prstGeom prst="rect">
              <a:avLst/>
            </a:prstGeom>
          </p:spPr>
        </p:pic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9A16F718-B8A4-AD4A-8D27-83BD863A91C1}"/>
              </a:ext>
            </a:extLst>
          </p:cNvPr>
          <p:cNvGrpSpPr/>
          <p:nvPr/>
        </p:nvGrpSpPr>
        <p:grpSpPr>
          <a:xfrm>
            <a:off x="1066800" y="2667000"/>
            <a:ext cx="4953000" cy="3733800"/>
            <a:chOff x="990600" y="4191000"/>
            <a:chExt cx="4953000" cy="37338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1" y="4191000"/>
              <a:ext cx="2438399" cy="18288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0600" y="6096000"/>
              <a:ext cx="2438399" cy="182880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5200" y="6096000"/>
              <a:ext cx="2438399" cy="18288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5201" y="4191000"/>
              <a:ext cx="2438399" cy="1828800"/>
            </a:xfrm>
            <a:prstGeom prst="rect">
              <a:avLst/>
            </a:prstGeom>
          </p:spPr>
        </p:pic>
      </p:grpSp>
      <p:sp>
        <p:nvSpPr>
          <p:cNvPr id="2" name="TextBox 1"/>
          <p:cNvSpPr txBox="1"/>
          <p:nvPr/>
        </p:nvSpPr>
        <p:spPr>
          <a:xfrm>
            <a:off x="228600" y="22860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28600" y="2438400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05C4742-86C9-BC48-BB36-12093AD45C68}"/>
              </a:ext>
            </a:extLst>
          </p:cNvPr>
          <p:cNvSpPr txBox="1"/>
          <p:nvPr/>
        </p:nvSpPr>
        <p:spPr>
          <a:xfrm>
            <a:off x="3427420" y="22860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6200" y="-76200"/>
            <a:ext cx="14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p</a:t>
            </a:r>
            <a:r>
              <a:rPr lang="en-US" dirty="0"/>
              <a:t> Figure 3</a:t>
            </a:r>
          </a:p>
        </p:txBody>
      </p:sp>
      <p:sp>
        <p:nvSpPr>
          <p:cNvPr id="20" name="Down Arrow 19"/>
          <p:cNvSpPr/>
          <p:nvPr/>
        </p:nvSpPr>
        <p:spPr>
          <a:xfrm>
            <a:off x="5181600" y="3104245"/>
            <a:ext cx="280692" cy="250403"/>
          </a:xfrm>
          <a:prstGeom prst="downArrow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Down Arrow 20"/>
          <p:cNvSpPr/>
          <p:nvPr/>
        </p:nvSpPr>
        <p:spPr>
          <a:xfrm>
            <a:off x="2761103" y="5933024"/>
            <a:ext cx="280692" cy="250403"/>
          </a:xfrm>
          <a:prstGeom prst="downArrow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Down Arrow 21"/>
          <p:cNvSpPr/>
          <p:nvPr/>
        </p:nvSpPr>
        <p:spPr>
          <a:xfrm rot="16654701">
            <a:off x="888092" y="3033123"/>
            <a:ext cx="205013" cy="643052"/>
          </a:xfrm>
          <a:prstGeom prst="downArrow">
            <a:avLst>
              <a:gd name="adj1" fmla="val 31415"/>
              <a:gd name="adj2" fmla="val 5552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Down Arrow 22"/>
          <p:cNvSpPr/>
          <p:nvPr/>
        </p:nvSpPr>
        <p:spPr>
          <a:xfrm rot="16654701">
            <a:off x="763130" y="4966282"/>
            <a:ext cx="205013" cy="643052"/>
          </a:xfrm>
          <a:prstGeom prst="downArrow">
            <a:avLst>
              <a:gd name="adj1" fmla="val 31415"/>
              <a:gd name="adj2" fmla="val 5552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Down Arrow 23"/>
          <p:cNvSpPr/>
          <p:nvPr/>
        </p:nvSpPr>
        <p:spPr>
          <a:xfrm rot="4236698">
            <a:off x="6178414" y="2795980"/>
            <a:ext cx="205013" cy="643052"/>
          </a:xfrm>
          <a:prstGeom prst="downArrow">
            <a:avLst>
              <a:gd name="adj1" fmla="val 31415"/>
              <a:gd name="adj2" fmla="val 5552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Down Arrow 24"/>
          <p:cNvSpPr/>
          <p:nvPr/>
        </p:nvSpPr>
        <p:spPr>
          <a:xfrm rot="4236698">
            <a:off x="6254613" y="4958741"/>
            <a:ext cx="205013" cy="643052"/>
          </a:xfrm>
          <a:prstGeom prst="downArrow">
            <a:avLst>
              <a:gd name="adj1" fmla="val 31415"/>
              <a:gd name="adj2" fmla="val 5552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Down Arrow 25"/>
          <p:cNvSpPr/>
          <p:nvPr/>
        </p:nvSpPr>
        <p:spPr>
          <a:xfrm rot="16654701">
            <a:off x="458331" y="684367"/>
            <a:ext cx="205013" cy="643052"/>
          </a:xfrm>
          <a:prstGeom prst="downArrow">
            <a:avLst>
              <a:gd name="adj1" fmla="val 31415"/>
              <a:gd name="adj2" fmla="val 55523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2963723" y="6412468"/>
            <a:ext cx="1236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T-Treated</a:t>
            </a:r>
          </a:p>
        </p:txBody>
      </p:sp>
      <p:sp>
        <p:nvSpPr>
          <p:cNvPr id="31" name="Down Arrow 30"/>
          <p:cNvSpPr/>
          <p:nvPr/>
        </p:nvSpPr>
        <p:spPr>
          <a:xfrm>
            <a:off x="5405078" y="1101569"/>
            <a:ext cx="280692" cy="250403"/>
          </a:xfrm>
          <a:prstGeom prst="downArrow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1886395" y="6727823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D)</a:t>
            </a:r>
            <a:endParaRPr lang="en-US" dirty="0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0981211"/>
              </p:ext>
            </p:extLst>
          </p:nvPr>
        </p:nvGraphicFramePr>
        <p:xfrm>
          <a:off x="2372783" y="6781800"/>
          <a:ext cx="2191871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3" name="Prism 7" r:id="rId16" imgW="3105450" imgH="3238505" progId="Prism7.Document">
                  <p:embed/>
                </p:oleObj>
              </mc:Choice>
              <mc:Fallback>
                <p:oleObj name="Prism 7" r:id="rId16" imgW="3105450" imgH="323850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372783" y="6781800"/>
                        <a:ext cx="2191871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61588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>
            <a:grpSpLocks noChangeAspect="1"/>
          </p:cNvGrpSpPr>
          <p:nvPr/>
        </p:nvGrpSpPr>
        <p:grpSpPr>
          <a:xfrm>
            <a:off x="533400" y="126380"/>
            <a:ext cx="5338620" cy="4293220"/>
            <a:chOff x="593245" y="1061482"/>
            <a:chExt cx="5872482" cy="472254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1736" y="1629942"/>
              <a:ext cx="2737639" cy="205323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25562" y="1629942"/>
              <a:ext cx="2737639" cy="205323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1736" y="3730797"/>
              <a:ext cx="2737639" cy="205323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28088" y="3730797"/>
              <a:ext cx="2737639" cy="2053230"/>
            </a:xfrm>
            <a:prstGeom prst="rect">
              <a:avLst/>
            </a:prstGeom>
          </p:spPr>
        </p:pic>
        <p:sp>
          <p:nvSpPr>
            <p:cNvPr id="13" name="Left Brace 12"/>
            <p:cNvSpPr/>
            <p:nvPr/>
          </p:nvSpPr>
          <p:spPr>
            <a:xfrm rot="5400000">
              <a:off x="2187978" y="131501"/>
              <a:ext cx="245151" cy="2737640"/>
            </a:xfrm>
            <a:prstGeom prst="leftBrace">
              <a:avLst>
                <a:gd name="adj1" fmla="val 43792"/>
                <a:gd name="adj2" fmla="val 51044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Left Brace 13"/>
            <p:cNvSpPr/>
            <p:nvPr/>
          </p:nvSpPr>
          <p:spPr>
            <a:xfrm rot="5400000">
              <a:off x="4971757" y="129022"/>
              <a:ext cx="245248" cy="2742690"/>
            </a:xfrm>
            <a:prstGeom prst="leftBrace">
              <a:avLst>
                <a:gd name="adj1" fmla="val 43792"/>
                <a:gd name="adj2" fmla="val 49578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51447" y="1061482"/>
              <a:ext cx="8817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Vehicle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455283" y="1080489"/>
              <a:ext cx="1297768" cy="372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DT-Treated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363118" y="2487280"/>
              <a:ext cx="7988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Fema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453784" y="4588134"/>
              <a:ext cx="6174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Male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52362" y="300865"/>
            <a:ext cx="5088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</a:p>
        </p:txBody>
      </p:sp>
      <p:grpSp>
        <p:nvGrpSpPr>
          <p:cNvPr id="43" name="Group 42"/>
          <p:cNvGrpSpPr>
            <a:grpSpLocks noChangeAspect="1"/>
          </p:cNvGrpSpPr>
          <p:nvPr/>
        </p:nvGrpSpPr>
        <p:grpSpPr>
          <a:xfrm>
            <a:off x="540269" y="4495800"/>
            <a:ext cx="5338350" cy="4343400"/>
            <a:chOff x="540269" y="4419600"/>
            <a:chExt cx="5338350" cy="4343400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9856" y="4986560"/>
              <a:ext cx="2488763" cy="1866573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9856" y="6896427"/>
              <a:ext cx="2488763" cy="1866573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9685" y="6893297"/>
              <a:ext cx="2488763" cy="1866573"/>
            </a:xfrm>
            <a:prstGeom prst="rect">
              <a:avLst/>
            </a:prstGeom>
          </p:spPr>
        </p:pic>
        <p:sp>
          <p:nvSpPr>
            <p:cNvPr id="37" name="Left Brace 36"/>
            <p:cNvSpPr/>
            <p:nvPr/>
          </p:nvSpPr>
          <p:spPr>
            <a:xfrm rot="5400000">
              <a:off x="1971125" y="5529462"/>
              <a:ext cx="222864" cy="2488764"/>
            </a:xfrm>
            <a:prstGeom prst="leftBrace">
              <a:avLst>
                <a:gd name="adj1" fmla="val 43792"/>
                <a:gd name="adj2" fmla="val 51044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Left Brace 37"/>
            <p:cNvSpPr/>
            <p:nvPr/>
          </p:nvSpPr>
          <p:spPr>
            <a:xfrm rot="5400000">
              <a:off x="4513866" y="3627332"/>
              <a:ext cx="222953" cy="2493355"/>
            </a:xfrm>
            <a:prstGeom prst="leftBrace">
              <a:avLst>
                <a:gd name="adj1" fmla="val 43792"/>
                <a:gd name="adj2" fmla="val 49578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676400" y="6324600"/>
              <a:ext cx="801611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Vehicle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078011" y="4419600"/>
              <a:ext cx="117978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DT-Treated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2859881" y="5771202"/>
              <a:ext cx="726189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Female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413486" y="7672695"/>
              <a:ext cx="561342" cy="307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Male</a:t>
              </a:r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253138" y="4888468"/>
            <a:ext cx="5088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6200" y="-76200"/>
            <a:ext cx="14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p</a:t>
            </a:r>
            <a:r>
              <a:rPr lang="en-US" dirty="0"/>
              <a:t> Figure 4</a:t>
            </a:r>
          </a:p>
        </p:txBody>
      </p:sp>
      <p:sp>
        <p:nvSpPr>
          <p:cNvPr id="26" name="Down Arrow 25"/>
          <p:cNvSpPr/>
          <p:nvPr/>
        </p:nvSpPr>
        <p:spPr>
          <a:xfrm rot="16200000">
            <a:off x="4131812" y="2779648"/>
            <a:ext cx="280692" cy="250403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Down Arrow 26"/>
          <p:cNvSpPr/>
          <p:nvPr/>
        </p:nvSpPr>
        <p:spPr>
          <a:xfrm rot="16200000">
            <a:off x="4382215" y="7089836"/>
            <a:ext cx="280692" cy="250403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0387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72" name="Picture 8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632" y="2667000"/>
            <a:ext cx="164592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3" name="Picture 9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2140" y="2667000"/>
            <a:ext cx="164592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4" name="Picture 10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7296" y="2667000"/>
            <a:ext cx="164592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5" name="Picture 11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2451" y="2667000"/>
            <a:ext cx="164592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62552" y="52544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-62552" y="2545245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295860" y="2545245"/>
            <a:ext cx="437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E)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269332" y="52544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643494" y="2545245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988334" y="2545245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F)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331372" y="449208"/>
          <a:ext cx="2974838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2" name="Prism 7" r:id="rId8" imgW="3799072" imgH="2627624" progId="Prism7.Document">
                  <p:embed/>
                </p:oleObj>
              </mc:Choice>
              <mc:Fallback>
                <p:oleObj name="Prism 7" r:id="rId8" imgW="3799072" imgH="2627624" progId="Prism7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1372" y="449208"/>
                        <a:ext cx="2974838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3773831" y="449208"/>
          <a:ext cx="3084169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3" name="Prism 7" r:id="rId10" imgW="3805194" imgH="2537972" progId="Prism7.Document">
                  <p:embed/>
                </p:oleObj>
              </mc:Choice>
              <mc:Fallback>
                <p:oleObj name="Prism 7" r:id="rId10" imgW="3805194" imgH="2537972" progId="Prism7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773831" y="449208"/>
                        <a:ext cx="3084169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76200" y="-76200"/>
            <a:ext cx="14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p</a:t>
            </a:r>
            <a:r>
              <a:rPr lang="en-US" dirty="0"/>
              <a:t> Figure 5</a:t>
            </a:r>
          </a:p>
        </p:txBody>
      </p:sp>
    </p:spTree>
    <p:extLst>
      <p:ext uri="{BB962C8B-B14F-4D97-AF65-F5344CB8AC3E}">
        <p14:creationId xmlns:p14="http://schemas.microsoft.com/office/powerpoint/2010/main" val="28406905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76200" y="32994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53883" y="32994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491924" y="329940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C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881207" y="32994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D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0" y="2604272"/>
            <a:ext cx="437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E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613493" y="2604272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F)</a:t>
            </a:r>
          </a:p>
        </p:txBody>
      </p:sp>
      <p:graphicFrame>
        <p:nvGraphicFramePr>
          <p:cNvPr id="17" name="Object 16"/>
          <p:cNvGraphicFramePr>
            <a:graphicFrameLocks noChangeAspect="1"/>
          </p:cNvGraphicFramePr>
          <p:nvPr>
            <p:extLst/>
          </p:nvPr>
        </p:nvGraphicFramePr>
        <p:xfrm>
          <a:off x="3429000" y="2812256"/>
          <a:ext cx="1770502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38" name="Prism 7" r:id="rId4" imgW="2518429" imgH="2926463" progId="Prism7.Document">
                  <p:embed/>
                </p:oleObj>
              </mc:Choice>
              <mc:Fallback>
                <p:oleObj name="Prism 7" r:id="rId4" imgW="2518429" imgH="2926463" progId="Prism7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29000" y="2812256"/>
                        <a:ext cx="1770502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/>
          </p:nvPr>
        </p:nvGraphicFramePr>
        <p:xfrm>
          <a:off x="5115406" y="2812256"/>
          <a:ext cx="1742594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39" name="Prism 7" r:id="rId6" imgW="2478814" imgH="2926463" progId="Prism7.Document">
                  <p:embed/>
                </p:oleObj>
              </mc:Choice>
              <mc:Fallback>
                <p:oleObj name="Prism 7" r:id="rId6" imgW="2478814" imgH="2926463" progId="Prism7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115406" y="2812256"/>
                        <a:ext cx="1742594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3378472" y="2604272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G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938596" y="2604272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H)</a:t>
            </a:r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/>
          </p:nvPr>
        </p:nvGraphicFramePr>
        <p:xfrm>
          <a:off x="3352800" y="623072"/>
          <a:ext cx="1718600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0" name="Prism 7" r:id="rId8" imgW="2439199" imgH="2921783" progId="Prism7.Document">
                  <p:embed/>
                </p:oleObj>
              </mc:Choice>
              <mc:Fallback>
                <p:oleObj name="Prism 7" r:id="rId8" imgW="2439199" imgH="2921783" progId="Prism7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52800" y="623072"/>
                        <a:ext cx="1718600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/>
          </p:nvPr>
        </p:nvGraphicFramePr>
        <p:xfrm>
          <a:off x="1725935" y="623072"/>
          <a:ext cx="1713570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1" name="Prism 7" r:id="rId10" imgW="2436318" imgH="2926463" progId="Prism7.Document">
                  <p:embed/>
                </p:oleObj>
              </mc:Choice>
              <mc:Fallback>
                <p:oleObj name="Prism 7" r:id="rId10" imgW="2436318" imgH="2926463" progId="Prism7.Document">
                  <p:embed/>
                  <p:pic>
                    <p:nvPicPr>
                      <p:cNvPr id="24" name="Object 23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725935" y="623072"/>
                        <a:ext cx="1713570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/>
          </p:nvPr>
        </p:nvGraphicFramePr>
        <p:xfrm>
          <a:off x="76200" y="623072"/>
          <a:ext cx="1707988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2" name="Prism 7" r:id="rId12" imgW="2428755" imgH="2926463" progId="Prism7.Document">
                  <p:embed/>
                </p:oleObj>
              </mc:Choice>
              <mc:Fallback>
                <p:oleObj name="Prism 7" r:id="rId12" imgW="2428755" imgH="2926463" progId="Prism7.Document">
                  <p:embed/>
                  <p:pic>
                    <p:nvPicPr>
                      <p:cNvPr id="26" name="Object 25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6200" y="623072"/>
                        <a:ext cx="1707988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76200" y="-76200"/>
            <a:ext cx="1460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p</a:t>
            </a:r>
            <a:r>
              <a:rPr lang="en-US" dirty="0"/>
              <a:t> Figure 6</a:t>
            </a:r>
          </a:p>
        </p:txBody>
      </p:sp>
      <p:sp>
        <p:nvSpPr>
          <p:cNvPr id="2" name="Rectangle 1"/>
          <p:cNvSpPr/>
          <p:nvPr/>
        </p:nvSpPr>
        <p:spPr>
          <a:xfrm>
            <a:off x="2398783" y="-39392"/>
            <a:ext cx="18133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57BL/6J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e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5115406" y="622170"/>
          <a:ext cx="1710220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3" name="Prism 7" r:id="rId14" imgW="2431636" imgH="2926463" progId="Prism7.Document">
                  <p:embed/>
                </p:oleObj>
              </mc:Choice>
              <mc:Fallback>
                <p:oleObj name="Prism 7" r:id="rId14" imgW="2431636" imgH="2926463" progId="Prism7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115406" y="622170"/>
                        <a:ext cx="1710220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6"/>
          <p:cNvSpPr txBox="1"/>
          <p:nvPr/>
        </p:nvSpPr>
        <p:spPr>
          <a:xfrm>
            <a:off x="0" y="4888468"/>
            <a:ext cx="383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I)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1613493" y="4888468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J)</a:t>
            </a:r>
            <a:endParaRPr lang="en-US" dirty="0"/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/>
          </p:nvPr>
        </p:nvGraphicFramePr>
        <p:xfrm>
          <a:off x="104219" y="4953000"/>
          <a:ext cx="1628729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4" name="Prism 7" r:id="rId16" imgW="2315673" imgH="2926463" progId="Prism7.Document">
                  <p:embed/>
                </p:oleObj>
              </mc:Choice>
              <mc:Fallback>
                <p:oleObj name="Prism 7" r:id="rId16" imgW="2315673" imgH="2926463" progId="Prism7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04219" y="4953000"/>
                        <a:ext cx="1628729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/>
          </p:nvPr>
        </p:nvGraphicFramePr>
        <p:xfrm>
          <a:off x="1924474" y="4953000"/>
          <a:ext cx="1580726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5" name="Prism 7" r:id="rId18" imgW="2248687" imgH="2926463" progId="Prism7.Document">
                  <p:embed/>
                </p:oleObj>
              </mc:Choice>
              <mc:Fallback>
                <p:oleObj name="Prism 7" r:id="rId18" imgW="2248687" imgH="2926463" progId="Prism7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924474" y="4953000"/>
                        <a:ext cx="1580726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 noChangeAspect="1"/>
          </p:cNvGraphicFramePr>
          <p:nvPr>
            <p:extLst/>
          </p:nvPr>
        </p:nvGraphicFramePr>
        <p:xfrm>
          <a:off x="1708547" y="2812256"/>
          <a:ext cx="1709104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6" name="Prism 7" r:id="rId20" imgW="2430196" imgH="2926463" progId="Prism7.Document">
                  <p:embed/>
                </p:oleObj>
              </mc:Choice>
              <mc:Fallback>
                <p:oleObj name="Prism 7" r:id="rId20" imgW="2430196" imgH="2926463" progId="Prism7.Document">
                  <p:embed/>
                  <p:pic>
                    <p:nvPicPr>
                      <p:cNvPr id="29" name="Object 28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708547" y="2812256"/>
                        <a:ext cx="1709104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/>
          </p:nvPr>
        </p:nvGraphicFramePr>
        <p:xfrm>
          <a:off x="6039" y="2812256"/>
          <a:ext cx="1763804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47" name="Prism 7" r:id="rId22" imgW="2507985" imgH="2926463" progId="Prism7.Document">
                  <p:embed/>
                </p:oleObj>
              </mc:Choice>
              <mc:Fallback>
                <p:oleObj name="Prism 7" r:id="rId22" imgW="2507985" imgH="2926463" progId="Prism7.Document">
                  <p:embed/>
                  <p:pic>
                    <p:nvPicPr>
                      <p:cNvPr id="30" name="Object 29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6039" y="2812256"/>
                        <a:ext cx="1763804" cy="205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382664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28600" y="152400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. Fig. 7</a:t>
            </a:r>
            <a:endParaRPr lang="en-US" dirty="0"/>
          </a:p>
        </p:txBody>
      </p:sp>
      <p:pic>
        <p:nvPicPr>
          <p:cNvPr id="7" name="Content Placeholder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1" y="3848100"/>
            <a:ext cx="3086099" cy="2057400"/>
          </a:xfrm>
          <a:prstGeom prst="rect">
            <a:avLst/>
          </a:prstGeom>
        </p:spPr>
      </p:pic>
      <p:pic>
        <p:nvPicPr>
          <p:cNvPr id="8" name="Content Placeholder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898" y="3886200"/>
            <a:ext cx="3086100" cy="20574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28600" y="553616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497670" y="553616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C)</a:t>
            </a:r>
            <a:endParaRPr lang="en-US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2743200" y="4762500"/>
            <a:ext cx="0" cy="30480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2667000" y="4152900"/>
            <a:ext cx="0" cy="30480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5867400" y="4305300"/>
            <a:ext cx="0" cy="30480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5105400" y="4303321"/>
            <a:ext cx="0" cy="30480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2362200" y="4087586"/>
            <a:ext cx="0" cy="30480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2057400" y="4210298"/>
            <a:ext cx="0" cy="30480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2286000" y="4876800"/>
            <a:ext cx="0" cy="30480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1439575" y="4914900"/>
            <a:ext cx="0" cy="30480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984738" y="1055077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A)</a:t>
            </a:r>
            <a:endParaRPr lang="en-US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7953349"/>
              </p:ext>
            </p:extLst>
          </p:nvPr>
        </p:nvGraphicFramePr>
        <p:xfrm>
          <a:off x="2114550" y="735013"/>
          <a:ext cx="2628900" cy="3178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2" name="Prism 7" r:id="rId6" imgW="2628270" imgH="3178136" progId="Prism7.Document">
                  <p:embed/>
                </p:oleObj>
              </mc:Choice>
              <mc:Fallback>
                <p:oleObj name="Prism 7" r:id="rId6" imgW="2628270" imgH="317813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114550" y="735013"/>
                        <a:ext cx="2628900" cy="3178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3477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8</TotalTime>
  <Words>186</Words>
  <Application>Microsoft Office PowerPoint</Application>
  <PresentationFormat>On-screen Show (4:3)</PresentationFormat>
  <Paragraphs>78</Paragraphs>
  <Slides>8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rism 7</vt:lpstr>
      <vt:lpstr>Prism 6</vt:lpstr>
      <vt:lpstr>Supplemental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aine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Michaela R. Reagan</dc:creator>
  <cp:lastModifiedBy>Michaela R. Reagan</cp:lastModifiedBy>
  <cp:revision>7</cp:revision>
  <dcterms:created xsi:type="dcterms:W3CDTF">2020-04-20T18:35:58Z</dcterms:created>
  <dcterms:modified xsi:type="dcterms:W3CDTF">2020-09-01T20:57:54Z</dcterms:modified>
</cp:coreProperties>
</file>